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1B179-8E7F-D947-91E6-C6AD6C93C0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D5944A-E47E-4947-9290-61BA3D1F8C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063599-BB9D-4D42-97FA-841695EAF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7A869B-111F-A948-90BB-0CB3C4D82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A9F2BB-A7B7-EE4A-9FEC-70BC72FC3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367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97CCEB-B0AC-444F-BD40-6BF9932E48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498707-C74D-864C-BA85-16DC4B0ED7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21E43-E7AD-B043-B31A-92C4021B4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DE5092-FFA2-A746-8658-3F314ADE9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FA2058-2BEA-A049-937C-4D57D86D4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23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C7AD00-1F84-BB49-AFF5-A922B40B87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3A58A6-0B26-B647-B3B4-13BDEE71B3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6AC37-D573-F94D-87A7-FE58D49C2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16829-37D7-1A4D-BC95-69519A5D9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AFFA94-640E-3B46-BED5-C0A589769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647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1798C5-D7D3-5243-B32B-23C0BE5A34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EE1C4-2783-A348-9E25-79D7DBDD56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C19DD-5ABE-F546-871C-121A10A6A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7A5B09-49C6-C744-A60B-136E0AF1E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328FFD-C5FC-0B41-9019-1F0EA2C81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894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393F7C-E765-B74A-91E4-801770BBD2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B16B38-483C-2D47-949A-2A3EA537C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8A71C-D65A-9F45-979E-3256E19BA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31FBE5-B4EF-144F-8E92-75FD09E1E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D6C7E5-EE2A-5F4A-924D-CA2D8BE50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097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6B447-2C33-B74B-8A20-205899E1D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17C9F3-61A7-4043-A6F4-F0E681B778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956B97-FFE7-0F40-AC1D-B26C7A8A2B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8D99F4-C641-7B41-B962-E6C63EC11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4CF039-F757-194D-9F8E-069DDD29D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241F55-00C4-9A4F-8D8D-975B24CCA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892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66CC59-7F36-B641-8DA9-98E1FC36B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A97A3C-913A-C245-BEF7-5F65939CED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15369F-36DE-864D-8DC7-C79F9D6C2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73A55D-AC4D-2941-A213-68151B8BB3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6C0557-65DE-B045-AEDF-4C0E5D8B58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BDE512-72A2-E642-BAAE-11D093723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F3A651-431C-674E-B4B1-8B09A6EBA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B673E6-6066-174D-84B1-92E0A8802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185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120662-126A-044E-B273-65613A6A2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0DBFFB-6B86-D64A-B723-2E944D334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9A4F21-885B-C146-9545-926FFF800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F60CFA-76E1-6D4C-B168-840AD9C34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833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C0719D-0AFC-3241-BAB2-27D716936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B15729-D29F-8445-A5F4-F7219CF64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EEF375-3714-A54F-8FD9-B0B49D21C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765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64EE7-3F94-4146-B1BF-9BF7EC1EE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4573FD-B48F-5740-B5D7-7D36CCB111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EEE6ED-3AFB-DC43-A2CF-79286CD6E4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A91264-1C39-8A4C-B73F-B8F5E53F7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CC3128-2D3B-EE40-A2F4-AAB2B8DBB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9E0990-B006-BE45-8610-B417DABA2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15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7616-5F7A-B64A-8664-00BB047CB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75D57B-7E43-E641-B22F-739DED0EE9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51F2AA-529C-B846-9E9E-E55EF6B9AD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12C5CE-67C3-2448-8861-963702811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25DEA6-5920-B14F-BC21-7E1C3E173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1F0699-833B-D04C-B996-966B70FA4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104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054B49-75FF-6E4C-825F-734B1FDAD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18322E-4939-A146-8F8B-CA0AE0A2B2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B46D1-4229-2040-ADA6-3A24C6F507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E491D-958C-BD4E-B692-F41F0E34C6F4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AF123-E105-1149-834B-0C56FDCFCA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AF9091-91A7-B34B-B8CC-0D2498251E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8FE97-AE2E-0A42-B3BC-A4F03249A1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1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716EE8F-182C-DD48-807B-217EA5F3437E}"/>
              </a:ext>
            </a:extLst>
          </p:cNvPr>
          <p:cNvSpPr/>
          <p:nvPr/>
        </p:nvSpPr>
        <p:spPr>
          <a:xfrm>
            <a:off x="3558822" y="243512"/>
            <a:ext cx="5074355" cy="63709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M   E   E   E   S   R   D   I   L   M   T   T   L   I   E   S   G   V   S   I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P   G   D   F   T   S   V   S   E   F   T   P   E   A   L   V   S   I   C   A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Q   L   L   N   L   I   D   P   S   A   S   F   S   D   E   L   P   D   S   L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c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P   E   R   F   R   I   C   T   D   I   A   H   S   V   K   N   L   G   Y   I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N   D   M   S   Y   Y   K   F   L   H   P   S   E   D   D   S   Y   R   L   V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R   F   L   V   E   R   L   S   E   I   S   E   G   R   K   T   L   T   A   G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D   I   A   S   R   P   K   M   E   T   F   R   D   I   S   D   D   M   M   V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gag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N   E   D   K   D   E   T   F   D   M   H   I   Q   K   V   E   A   V   L   K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D   L   T   M   T   S   E   K   S   H   S   S   D   S   L   A   K   N   T   S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ga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   N   V   D   F   S   S   Q   K   T   D   D   P   V   T   D   V   R   S   D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aca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L   S   L   R   D   S   S   R   C   E   E   N   S   Y   E   D   P   F   E   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gag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N   Y   E   T   V   E   L   Q   N   Q   H   D   V   L   L   E   E   L   E   S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   S   S   Q   L   C   S   L   E   S   E   L   E   L   L   Q   M   A   A   E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R   L   L   D   D   K   K   P   G   G   S   Y   L   E   Q   L   N   Q   Q   L  </a:t>
            </a:r>
            <a:b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V   V   K   R   C   N   I   M   D   L   K   K   Q   W   D   D   V   R   L   T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gtg gag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L   E   T   K   K   L   L   L   L   D   Q   L   H   V   E   E   P   E   A   K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E   K   F   H   K   L   R   K   T   E   L   D   L   Q   S   L   S   S   E   I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Q   K   R   E   D   E   R   C   N   L   Y   N   E   L   E   R   Q   P   K   A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   P   R   K   S   Y   I   H   G   I   K   E   I   T   K   N   S   R   K   L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ac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D   T   D   I   Q   R   I   S   G   E   T   R   E   L   Q   L   E   K   N   S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I   Q   E   R   L   H   R   S   Y   A   V   V   D   E   M   V   T   R   E   V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K   K   D   P   A   V   R   Q   V   Y   K   L   L   T   S   I   H   S   I   F  </a:t>
            </a:r>
            <a:b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tat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Q   I   S   E   K   I   L   M   T   D   R   F   R   R   E   T   V   D   Y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E   K   K   L   G   S   I   T   A   R   G   M   S   L   E   K   L   Q   A   D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L   D   A   I   R   K   E   N   E   S   L   K   K   -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800" dirty="0">
                <a:latin typeface="Courier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5720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6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1</cp:revision>
  <dcterms:created xsi:type="dcterms:W3CDTF">2022-09-13T16:45:35Z</dcterms:created>
  <dcterms:modified xsi:type="dcterms:W3CDTF">2022-11-18T19:09:24Z</dcterms:modified>
</cp:coreProperties>
</file>